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6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92"/>
    <p:restoredTop sz="91345"/>
  </p:normalViewPr>
  <p:slideViewPr>
    <p:cSldViewPr snapToGrid="0" snapToObjects="1" showGuides="1">
      <p:cViewPr varScale="1">
        <p:scale>
          <a:sx n="115" d="100"/>
          <a:sy n="115" d="100"/>
        </p:scale>
        <p:origin x="1064" y="192"/>
      </p:cViewPr>
      <p:guideLst>
        <p:guide orient="horz" pos="2160"/>
        <p:guide pos="386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F94C89-25ED-CE4F-AF31-68BE214D7AC3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EA1854D-0E60-2344-8E5B-D25C109DB7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15083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EA1854D-0E60-2344-8E5B-D25C109DB78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4616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CF5DD8-EDD2-4FE4-652A-D8D07E2E61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D712C0C-ABF2-DD49-1A4B-F319392FEA8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E3443A8-01E0-D329-7FDE-218F6F6A4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C3F825-678D-4CBB-2E89-4FD361AA7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20125D7-80A3-7167-C6BB-1163B3706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089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B23E0B6-57BA-C050-9CFE-987CFF7EE3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4CD5AA2-5781-07DD-8845-1DC2A9BE10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0357EA-F179-4E11-5BCA-B9F48CCE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F6657F-AC55-4660-9D95-0ABFC5DDB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272B7E-1DB1-E894-6BF0-724347EF86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0969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428D5B7-75A6-383B-02F3-DD19A8635C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65F4B9E-7308-2142-6366-18CD8BE0CD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EC584A-AE45-F443-1F41-543C68E73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93FB683-49A6-79E7-792E-0E599DC5C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8380F5F-4CF0-F38A-561D-3BBFF9259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1737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9D2F63-D9A2-0B36-937C-EEAD8846C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7201EEE-8150-ECC5-1F15-6D19788877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F86B1B2-99B7-5DB7-BD0F-25447090D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F54B609-6C29-6437-CEF0-4E6BD84AE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5717F71-42F5-D47D-83AF-5B96999C4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3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21C929-FBDE-205A-0292-58D8D0628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EF672A-236D-CC2F-BA85-F0CAD5A57A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1091C-69C3-0E46-C733-E237B63E14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651B85-5B50-F503-D60A-B38F4764B8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90B500-99A6-92C3-8B64-09652A385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8684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27EF2A-6E25-16D8-3C2D-8E050F51EE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98D370C-20F1-0621-91B2-19B0AAD7E3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B1A9F68-03B4-5D55-0516-1D6A3E1326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B0C9299-E7D2-200C-35F7-3F8F81977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548E5D5-2217-1E0A-F440-A2237A0E0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41A6207-D28E-8770-AE6D-182002D88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57478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D8E78E2-75B7-90BD-5DFD-DBEE49CAA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6266ABE-B630-8E00-CDE6-9D1E991925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05D1C17-56CE-C1F6-D111-FF92A376F7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D50C916-3BF6-2586-0E41-B0E3FC46FE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590975F-9943-BF29-D64A-5FAC636534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ADEC886-14DC-02DA-4357-4D7ED65D2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88F8375-865D-8957-6737-E99C6608F9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12B3B00-EB37-B538-3553-8D450A4EA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7536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CDBA17A-365D-530A-DDCF-F4D0F6298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74CE39B-7E1C-A644-A4E1-7A43A9DAB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208A82B-F263-7DD0-2353-0C1C48714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AC4E941-6B22-D5C8-6546-4AF94C89B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1506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37B737E-D5BF-EABE-3F8C-B90BB45489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92BCB01-CA8C-DA43-577D-80BDD329A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C7E3DB8-A8C4-5925-C08D-376BC6D55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852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6C43C0-4C8E-714F-D6D5-F37C2DA14B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064642-A441-D451-7DE6-8FC4B7330D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E4523D0-0CA0-7330-2BA0-A71809937B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943132C-8639-A504-7639-9F0F18112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31569F8-DA57-1C12-6F34-4D5C851F7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4A7C069-B54F-0943-1F15-F31AC792C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582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3B4A598-CAE5-E955-11F9-70CCC882E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EDEDE58-19E0-E493-AA6E-2FF7573572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F20382E-2F2C-2132-456F-1885A82AAA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108EB51-FA1B-B967-6882-BD806BADC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A7B5871-7266-4A36-FFA4-AF078807EA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5829451-1F02-DB56-EF68-40FC57E130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6835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B15F5DF-63E0-07E4-DF00-E4B3D9D724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8256C7-6314-C495-A0AE-194450041A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F0932D-1BD1-6C5B-8E34-A2BE508231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E922E-D36D-8A4B-AC98-710EEC29C31C}" type="datetimeFigureOut">
              <a:rPr kumimoji="1" lang="ja-JP" altLang="en-US" smtClean="0"/>
              <a:t>2022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FC19C7-7136-91B4-1CCD-CC74C3355A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555258-D135-B290-F7C4-A6CB1C015D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9FA492-CC88-6A48-8F6B-0717951940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9354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394EB23-04B5-F98F-6D43-2BA7DC7F311C}"/>
              </a:ext>
            </a:extLst>
          </p:cNvPr>
          <p:cNvSpPr txBox="1"/>
          <p:nvPr/>
        </p:nvSpPr>
        <p:spPr>
          <a:xfrm>
            <a:off x="532262" y="1564395"/>
            <a:ext cx="111653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1. PFS (A) and OS (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</a:rPr>
              <a:t>B) 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of patients with or without a refractory response to prior </a:t>
            </a:r>
            <a:r>
              <a:rPr lang="en-US" altLang="ja-JP" sz="18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nonliposomal</a:t>
            </a:r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irinotecan</a:t>
            </a:r>
            <a:endParaRPr lang="ja-JP" altLang="ja-JP" sz="1800">
              <a:effectLst/>
              <a:latin typeface="Times New Roman" panose="02020603050405020304" pitchFamily="18" charset="0"/>
              <a:ea typeface="游明朝" panose="02020400000000000000" pitchFamily="18" charset="-128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F9BF844-507D-DF17-7B29-C2108F406404}"/>
              </a:ext>
            </a:extLst>
          </p:cNvPr>
          <p:cNvSpPr txBox="1"/>
          <p:nvPr/>
        </p:nvSpPr>
        <p:spPr>
          <a:xfrm>
            <a:off x="532262" y="925417"/>
            <a:ext cx="1460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ure legend</a:t>
            </a:r>
            <a:endParaRPr lang="ja-JP" altLang="ja-JP" sz="1800">
              <a:effectLst/>
              <a:latin typeface="Times New Roman" panose="02020603050405020304" pitchFamily="18" charset="0"/>
              <a:ea typeface="游明朝" panose="02020400000000000000" pitchFamily="18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263264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662B9DB-F25A-2C88-1355-1667A44E964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-415455"/>
            <a:ext cx="6400800" cy="640080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7C29C92-9E88-E1EF-523D-7F01818ECE0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00310" y="-415455"/>
            <a:ext cx="6400800" cy="6400800"/>
          </a:xfrm>
          <a:prstGeom prst="rect">
            <a:avLst/>
          </a:prstGeom>
        </p:spPr>
      </p:pic>
      <p:graphicFrame>
        <p:nvGraphicFramePr>
          <p:cNvPr id="11" name="表 2">
            <a:extLst>
              <a:ext uri="{FF2B5EF4-FFF2-40B4-BE49-F238E27FC236}">
                <a16:creationId xmlns:a16="http://schemas.microsoft.com/office/drawing/2014/main" id="{8C688971-899B-47F4-8043-C967B6B28E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07120123"/>
              </p:ext>
            </p:extLst>
          </p:nvPr>
        </p:nvGraphicFramePr>
        <p:xfrm>
          <a:off x="403777" y="5899666"/>
          <a:ext cx="5472237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24079">
                  <a:extLst>
                    <a:ext uri="{9D8B030D-6E8A-4147-A177-3AD203B41FA5}">
                      <a16:colId xmlns:a16="http://schemas.microsoft.com/office/drawing/2014/main" val="650372687"/>
                    </a:ext>
                  </a:extLst>
                </a:gridCol>
                <a:gridCol w="1824079">
                  <a:extLst>
                    <a:ext uri="{9D8B030D-6E8A-4147-A177-3AD203B41FA5}">
                      <a16:colId xmlns:a16="http://schemas.microsoft.com/office/drawing/2014/main" val="499889753"/>
                    </a:ext>
                  </a:extLst>
                </a:gridCol>
                <a:gridCol w="1824079">
                  <a:extLst>
                    <a:ext uri="{9D8B030D-6E8A-4147-A177-3AD203B41FA5}">
                      <a16:colId xmlns:a16="http://schemas.microsoft.com/office/drawing/2014/main" val="32854943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or irinotecan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FS</a:t>
                      </a:r>
                      <a:r>
                        <a:rPr kumimoji="1" lang="ja-JP" altLang="en-US" sz="14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)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400" i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2104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6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4964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37287"/>
                  </a:ext>
                </a:extLst>
              </a:tr>
            </a:tbl>
          </a:graphicData>
        </a:graphic>
      </p:graphicFrame>
      <p:graphicFrame>
        <p:nvGraphicFramePr>
          <p:cNvPr id="12" name="表 2">
            <a:extLst>
              <a:ext uri="{FF2B5EF4-FFF2-40B4-BE49-F238E27FC236}">
                <a16:creationId xmlns:a16="http://schemas.microsoft.com/office/drawing/2014/main" id="{41997AA2-099C-CC4A-6FB2-9173E26F6D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06328886"/>
              </p:ext>
            </p:extLst>
          </p:nvPr>
        </p:nvGraphicFramePr>
        <p:xfrm>
          <a:off x="6315986" y="5899666"/>
          <a:ext cx="5472237" cy="914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24079">
                  <a:extLst>
                    <a:ext uri="{9D8B030D-6E8A-4147-A177-3AD203B41FA5}">
                      <a16:colId xmlns:a16="http://schemas.microsoft.com/office/drawing/2014/main" val="650372687"/>
                    </a:ext>
                  </a:extLst>
                </a:gridCol>
                <a:gridCol w="1824079">
                  <a:extLst>
                    <a:ext uri="{9D8B030D-6E8A-4147-A177-3AD203B41FA5}">
                      <a16:colId xmlns:a16="http://schemas.microsoft.com/office/drawing/2014/main" val="499889753"/>
                    </a:ext>
                  </a:extLst>
                </a:gridCol>
                <a:gridCol w="1824079">
                  <a:extLst>
                    <a:ext uri="{9D8B030D-6E8A-4147-A177-3AD203B41FA5}">
                      <a16:colId xmlns:a16="http://schemas.microsoft.com/office/drawing/2014/main" val="328549430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or irinotecan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</a:t>
                      </a:r>
                      <a:r>
                        <a:rPr kumimoji="1" lang="ja-JP" altLang="en-US" sz="14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)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i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kumimoji="1" lang="en-US" altLang="ja-JP" sz="1400" i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kumimoji="1" lang="en-US" altLang="ja-JP" sz="14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lue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21042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4964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</a:t>
                      </a:r>
                      <a:endParaRPr kumimoji="1" lang="ja-JP" altLang="en-US" sz="14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137287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AD6D81C-3CC4-CE29-0271-BBCDDE1CB5C2}"/>
              </a:ext>
            </a:extLst>
          </p:cNvPr>
          <p:cNvSpPr txBox="1"/>
          <p:nvPr/>
        </p:nvSpPr>
        <p:spPr>
          <a:xfrm>
            <a:off x="320238" y="52581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F1E5630-D5E7-4F6F-5BA9-3DD42E5B76BB}"/>
              </a:ext>
            </a:extLst>
          </p:cNvPr>
          <p:cNvSpPr txBox="1"/>
          <p:nvPr/>
        </p:nvSpPr>
        <p:spPr>
          <a:xfrm>
            <a:off x="6167438" y="52581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2439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6</TotalTime>
  <Words>54</Words>
  <Application>Microsoft Macintosh PowerPoint</Application>
  <PresentationFormat>ワイド画面</PresentationFormat>
  <Paragraphs>2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上 武志</dc:creator>
  <cp:lastModifiedBy>川上 武志</cp:lastModifiedBy>
  <cp:revision>14</cp:revision>
  <dcterms:created xsi:type="dcterms:W3CDTF">2022-04-26T12:27:53Z</dcterms:created>
  <dcterms:modified xsi:type="dcterms:W3CDTF">2022-09-24T06:43:56Z</dcterms:modified>
</cp:coreProperties>
</file>